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6925"/>
  </p:normalViewPr>
  <p:slideViewPr>
    <p:cSldViewPr snapToGrid="0" snapToObjects="1">
      <p:cViewPr varScale="1">
        <p:scale>
          <a:sx n="107" d="100"/>
          <a:sy n="107" d="100"/>
        </p:scale>
        <p:origin x="3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05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172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652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0504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1194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3371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028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6928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2435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9786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9002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A88D1-1892-B44D-8FEE-9AB9620FB6FB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95F69-9E22-4843-BC10-2B36827903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3182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package" Target="../embeddings/Feuille_de_calcul_Microsoft_Excel.xlsx"/><Relationship Id="rId7" Type="http://schemas.openxmlformats.org/officeDocument/2006/relationships/package" Target="../embeddings/Feuille_de_calcul_Microsoft_Excel2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package" Target="../embeddings/Feuille_de_calcul_Microsoft_Excel1.xlsx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C166B6B5-5DE8-6949-A478-5DCD01CAB960}"/>
              </a:ext>
            </a:extLst>
          </p:cNvPr>
          <p:cNvSpPr txBox="1"/>
          <p:nvPr/>
        </p:nvSpPr>
        <p:spPr>
          <a:xfrm>
            <a:off x="691685" y="98785"/>
            <a:ext cx="49725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file 4.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mmar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ligotype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ocalit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and per OTU of </a:t>
            </a:r>
            <a:r>
              <a:rPr lang="fr-FR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pirochaeta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EF306FCF-C0FA-574C-BA6C-3174E02A33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8553411"/>
              </p:ext>
            </p:extLst>
          </p:nvPr>
        </p:nvGraphicFramePr>
        <p:xfrm>
          <a:off x="4138613" y="585850"/>
          <a:ext cx="1525587" cy="4910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Feuille de calcul" r:id="rId3" imgW="3289300" imgH="10604500" progId="Excel.Sheet.12">
                  <p:embed/>
                </p:oleObj>
              </mc:Choice>
              <mc:Fallback>
                <p:oleObj name="Feuille de calcul" r:id="rId3" imgW="3289300" imgH="10604500" progId="Excel.Sheet.12">
                  <p:embed/>
                  <p:pic>
                    <p:nvPicPr>
                      <p:cNvPr id="8" name="Objet 7">
                        <a:extLst>
                          <a:ext uri="{FF2B5EF4-FFF2-40B4-BE49-F238E27FC236}">
                            <a16:creationId xmlns:a16="http://schemas.microsoft.com/office/drawing/2014/main" id="{51063AEE-721C-F74D-8DA3-496E815C7B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38613" y="585850"/>
                        <a:ext cx="1525587" cy="4910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4C42B604-0DDF-3F4B-AFF8-55C62BC7A8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2148151"/>
              </p:ext>
            </p:extLst>
          </p:nvPr>
        </p:nvGraphicFramePr>
        <p:xfrm>
          <a:off x="691685" y="587438"/>
          <a:ext cx="1643063" cy="4908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Feuille de calcul" r:id="rId5" imgW="3543300" imgH="10579100" progId="Excel.Sheet.12">
                  <p:embed/>
                </p:oleObj>
              </mc:Choice>
              <mc:Fallback>
                <p:oleObj name="Feuille de calcul" r:id="rId5" imgW="3543300" imgH="10579100" progId="Excel.Sheet.12">
                  <p:embed/>
                  <p:pic>
                    <p:nvPicPr>
                      <p:cNvPr id="9" name="Objet 8">
                        <a:extLst>
                          <a:ext uri="{FF2B5EF4-FFF2-40B4-BE49-F238E27FC236}">
                            <a16:creationId xmlns:a16="http://schemas.microsoft.com/office/drawing/2014/main" id="{0BD528FD-2EBA-334D-B5ED-9E8C227CAD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91685" y="587438"/>
                        <a:ext cx="1643063" cy="4908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t 10">
            <a:extLst>
              <a:ext uri="{FF2B5EF4-FFF2-40B4-BE49-F238E27FC236}">
                <a16:creationId xmlns:a16="http://schemas.microsoft.com/office/drawing/2014/main" id="{527FBECB-F85C-1546-BC50-098EC35944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4308081"/>
              </p:ext>
            </p:extLst>
          </p:nvPr>
        </p:nvGraphicFramePr>
        <p:xfrm>
          <a:off x="2447693" y="585850"/>
          <a:ext cx="1577975" cy="929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Feuille de calcul" r:id="rId7" imgW="3454400" imgH="20358100" progId="Excel.Sheet.12">
                  <p:embed/>
                </p:oleObj>
              </mc:Choice>
              <mc:Fallback>
                <p:oleObj name="Feuille de calcul" r:id="rId7" imgW="3454400" imgH="20358100" progId="Excel.Sheet.12">
                  <p:embed/>
                  <p:pic>
                    <p:nvPicPr>
                      <p:cNvPr id="11" name="Objet 10">
                        <a:extLst>
                          <a:ext uri="{FF2B5EF4-FFF2-40B4-BE49-F238E27FC236}">
                            <a16:creationId xmlns:a16="http://schemas.microsoft.com/office/drawing/2014/main" id="{64D44249-6553-4C4A-9305-F1ADF2A57A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47693" y="585850"/>
                        <a:ext cx="1577975" cy="9296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944276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8</Words>
  <Application>Microsoft Macintosh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Feuille de calcul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5</cp:revision>
  <dcterms:created xsi:type="dcterms:W3CDTF">2020-12-22T17:33:43Z</dcterms:created>
  <dcterms:modified xsi:type="dcterms:W3CDTF">2020-12-23T21:42:39Z</dcterms:modified>
</cp:coreProperties>
</file>